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4252575" cy="106886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487C862-2E41-446C-BB8C-4BF3DF542024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122904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979560" y="6386040"/>
            <a:ext cx="122904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8EA19E6-17C6-41E9-B81C-7659FDB60A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277400" y="284472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979560" y="638604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277400" y="638604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91FE0D8-7EDE-4E4C-9CCD-AA134C99F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395712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135040" y="2844720"/>
            <a:ext cx="395712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290160" y="2844720"/>
            <a:ext cx="395712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979560" y="6386040"/>
            <a:ext cx="395712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135040" y="6386040"/>
            <a:ext cx="395712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290160" y="6386040"/>
            <a:ext cx="395712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19432B6-042A-4BE4-86E4-48B5A7132CFD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979560" y="2844720"/>
            <a:ext cx="12290400" cy="6780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C827BB0-FE92-469F-A1F5-01BAF13C65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12290400" cy="678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A97E104-3274-4994-82C0-A6036CC96C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5997600" cy="678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277400" y="2844720"/>
            <a:ext cx="5997600" cy="678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5B96A9A-54AB-42AF-82B8-69CCA84BFA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D7ED755-A27B-4937-9572-0E847E6557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979560" y="568080"/>
            <a:ext cx="12290400" cy="957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0000"/>
              </a:lnSpc>
              <a:spcBef>
                <a:spcPts val="1562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7DC446E-5F95-4D9B-BDFB-7020F09D79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277400" y="2844720"/>
            <a:ext cx="5997600" cy="678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979560" y="638604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137A70E-DD5D-4A6A-AFE2-C7AB8EF18F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5997600" cy="678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277400" y="284472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277400" y="638604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B97E0DE-78EF-437C-B5F5-3B6F6DC3DC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979560" y="284472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277400" y="2844720"/>
            <a:ext cx="59976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979560" y="6386040"/>
            <a:ext cx="12290400" cy="323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555CB45-0D8E-4555-A6B4-F77544AE5F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79560" y="568080"/>
            <a:ext cx="12290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6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79560" y="2844720"/>
            <a:ext cx="12290400" cy="678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562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0000"/>
              </a:lnSpc>
              <a:spcBef>
                <a:spcPts val="1562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0000"/>
              </a:lnSpc>
              <a:spcBef>
                <a:spcPts val="1562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0000"/>
              </a:lnSpc>
              <a:spcBef>
                <a:spcPts val="1562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0000"/>
              </a:lnSpc>
              <a:spcBef>
                <a:spcPts val="1562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0000"/>
              </a:lnSpc>
              <a:spcBef>
                <a:spcPts val="1562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0000"/>
              </a:lnSpc>
              <a:spcBef>
                <a:spcPts val="1562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979200" y="9906120"/>
            <a:ext cx="3205080" cy="56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4721400" y="9906120"/>
            <a:ext cx="4808520" cy="56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10064520" y="9906120"/>
            <a:ext cx="3205080" cy="56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0C5A5AD-3926-4551-A0DA-9085360FDB03}" type="slidenum">
              <a:rPr b="0" lang="en-GB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3104" t="6453" r="18310" b="5530"/>
          <a:stretch/>
        </p:blipFill>
        <p:spPr>
          <a:xfrm>
            <a:off x="1000080" y="1069920"/>
            <a:ext cx="12465000" cy="82137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073160" y="457200"/>
            <a:ext cx="120934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10760"/>
                <a:tab algn="l" pos="10134720"/>
                <a:tab algn="l" pos="10858680"/>
                <a:tab algn="l" pos="11582280"/>
              </a:tabLst>
            </a:pPr>
            <a:r>
              <a:rPr b="1" lang="en-US" sz="1400" spc="-1" strike="noStrike">
                <a:solidFill>
                  <a:srgbClr val="131413"/>
                </a:solidFill>
                <a:latin typeface="Calibri,Bold"/>
                <a:ea typeface="Calibri,Bold"/>
              </a:rPr>
              <a:t>Figure S1</a:t>
            </a:r>
            <a:r>
              <a:rPr b="0" lang="en-US" sz="1400" spc="-1" strike="noStrike">
                <a:solidFill>
                  <a:srgbClr val="131413"/>
                </a:solidFill>
                <a:latin typeface="Calibri"/>
                <a:ea typeface="Calibri"/>
              </a:rPr>
              <a:t>. Alcohol consumption during the last year in three surveys from the </a:t>
            </a:r>
            <a:r>
              <a:rPr b="0" lang="en-US" sz="1400" spc="-1" strike="noStrike">
                <a:solidFill>
                  <a:srgbClr val="131413"/>
                </a:solidFill>
                <a:latin typeface="Calibri"/>
                <a:ea typeface="Calibri"/>
              </a:rPr>
              <a:t>Tromsø Study1 (Additional file </a:t>
            </a:r>
            <a:r>
              <a:rPr b="0" lang="en-US" sz="1400" spc="-1" strike="noStrike">
                <a:solidFill>
                  <a:srgbClr val="0000ff"/>
                </a:solidFill>
                <a:latin typeface="Calibri"/>
                <a:ea typeface="Calibri"/>
              </a:rPr>
              <a:t>2</a:t>
            </a:r>
            <a:r>
              <a:rPr b="0" lang="en-US" sz="1400" spc="-1" strike="noStrike">
                <a:solidFill>
                  <a:srgbClr val="131413"/>
                </a:solidFill>
                <a:latin typeface="Calibri"/>
                <a:ea typeface="Calibri"/>
              </a:rPr>
              <a:t>, .pptx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"/>
          <p:cNvSpPr/>
          <p:nvPr/>
        </p:nvSpPr>
        <p:spPr>
          <a:xfrm>
            <a:off x="1096920" y="9418680"/>
            <a:ext cx="6410520" cy="30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131413"/>
                </a:solidFill>
                <a:latin typeface="Calibri"/>
                <a:ea typeface="Calibri"/>
              </a:rPr>
              <a:t>Tromsø 4 = 1994–95, Tromsø 6 = 2007–08, and Tromsø 7 = 2015–16. From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crude data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3-10T09:11:26Z</dcterms:created>
  <dc:creator>Stelander Line Tegner</dc:creator>
  <dc:description/>
  <dc:language>en-US</dc:language>
  <cp:lastModifiedBy>Stelander Line Tegner</cp:lastModifiedBy>
  <dcterms:modified xsi:type="dcterms:W3CDTF">2021-04-12T10:15:16Z</dcterms:modified>
  <cp:revision>4</cp:revision>
  <dc:subject/>
  <dc:title>PowerPoint-presentasjon</dc:title>
</cp:coreProperties>
</file>